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6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6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A856B9-DF08-4341-8434-23BC0A0F7DA1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E27A1-F44C-5D4F-9D5D-64F3C879E8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2583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E27A1-F44C-5D4F-9D5D-64F3C879E817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4409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BE7B9-2E22-B44E-B11B-719BFA304944}" type="datetimeFigureOut">
              <a:rPr kumimoji="1" lang="zh-CN" altLang="en-US" smtClean="0"/>
              <a:t>2024/6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9495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205CBB2B-E4BB-24BA-9CAA-CE41C3CFF2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7772647"/>
              </p:ext>
            </p:extLst>
          </p:nvPr>
        </p:nvGraphicFramePr>
        <p:xfrm>
          <a:off x="525780" y="1295400"/>
          <a:ext cx="5679134" cy="36576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67548">
                  <a:extLst>
                    <a:ext uri="{9D8B030D-6E8A-4147-A177-3AD203B41FA5}">
                      <a16:colId xmlns:a16="http://schemas.microsoft.com/office/drawing/2014/main" val="1421323512"/>
                    </a:ext>
                  </a:extLst>
                </a:gridCol>
                <a:gridCol w="1832834">
                  <a:extLst>
                    <a:ext uri="{9D8B030D-6E8A-4147-A177-3AD203B41FA5}">
                      <a16:colId xmlns:a16="http://schemas.microsoft.com/office/drawing/2014/main" val="2173809816"/>
                    </a:ext>
                  </a:extLst>
                </a:gridCol>
                <a:gridCol w="797626">
                  <a:extLst>
                    <a:ext uri="{9D8B030D-6E8A-4147-A177-3AD203B41FA5}">
                      <a16:colId xmlns:a16="http://schemas.microsoft.com/office/drawing/2014/main" val="2032680207"/>
                    </a:ext>
                  </a:extLst>
                </a:gridCol>
                <a:gridCol w="1081126">
                  <a:extLst>
                    <a:ext uri="{9D8B030D-6E8A-4147-A177-3AD203B41FA5}">
                      <a16:colId xmlns:a16="http://schemas.microsoft.com/office/drawing/2014/main" val="44921945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os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ifier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920763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SP3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2579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26328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llipor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B374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014560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IF2</a:t>
                      </a:r>
                      <a:r>
                        <a:rPr lang="en-US" sz="1000" b="0" kern="100" dirty="0">
                          <a:effectLst/>
                          <a:latin typeface="Symbol" pitchFamily="2" charset="2"/>
                          <a:cs typeface="Times New Roman" panose="02020603050405020304" pitchFamily="18" charset="0"/>
                        </a:rPr>
                        <a:t>a</a:t>
                      </a:r>
                      <a:endParaRPr lang="ja-JP" sz="1000" b="0" kern="100">
                        <a:effectLst/>
                        <a:latin typeface="Symbol" pitchFamily="2" charset="2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722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633176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ospho-eIF2</a:t>
                      </a:r>
                      <a:r>
                        <a:rPr lang="en-US" sz="1000" b="0" kern="100" dirty="0">
                          <a:effectLst/>
                          <a:latin typeface="Symbol" pitchFamily="2" charset="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Ser51)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72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154703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DH2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8610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016614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trate synthase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14309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048533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H2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56439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020005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HA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11998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01982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marase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4567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182194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XPHOS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1041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879060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XPHOX CI subunit NDUFB8 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11024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62137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XPHOX CII </a:t>
                      </a:r>
                      <a:r>
                        <a:rPr lang="en-US" altLang="ja-JP" sz="1000" b="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ubunit SDHB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sz="1000" b="0" i="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14714</a:t>
                      </a:r>
                      <a:endParaRPr lang="en-US" sz="1000" b="0" u="none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98017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XPHOX CIII subunit UQCRC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sz="1000" b="0" i="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14745</a:t>
                      </a:r>
                      <a:endParaRPr lang="en-US" sz="1000" b="0" u="none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895307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XPHOX CIV subunit MTCO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" sz="1000" b="0" i="0" u="non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14705</a:t>
                      </a:r>
                      <a:endParaRPr lang="en-US" sz="1000" b="0" u="none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0467483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XPHOX CV subunit ATP5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ouse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1474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82496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Myc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5605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17169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NA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13110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997756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eaved-caspase3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 Technolog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#966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629588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F1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Rabbi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3377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291848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000" b="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FAM</a:t>
                      </a:r>
                      <a:endParaRPr lang="ja-JP" sz="1000" b="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oat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000" kern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23588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230030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abbit IgG (H+L), HRP Conjugat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romega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oa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401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69173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use IgG (H+L), HRP Conjugat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romega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oat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W402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892355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1000" b="0" i="0" u="none" strike="noStrike" kern="1200" dirty="0">
                          <a:solidFill>
                            <a:schemeClr val="lt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oat IgG, HRP Conjugat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Promega</a:t>
                      </a:r>
                      <a:endParaRPr lang="ja-JP" alt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Donkey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ja-JP" sz="10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V8051</a:t>
                      </a:r>
                      <a:endParaRPr lang="ja-JP" sz="10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32442718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2EBED22-7755-E65B-D662-B9D4020E72F4}"/>
              </a:ext>
            </a:extLst>
          </p:cNvPr>
          <p:cNvSpPr txBox="1"/>
          <p:nvPr/>
        </p:nvSpPr>
        <p:spPr>
          <a:xfrm>
            <a:off x="656308" y="730221"/>
            <a:ext cx="32146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Table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kumimoji="0" lang="ja-JP" altLang="ja-JP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used in this study</a:t>
            </a:r>
            <a:endParaRPr kumimoji="0" lang="ja-JP" altLang="ja-JP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1134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6</TotalTime>
  <Words>179</Words>
  <Application>Microsoft Macintosh PowerPoint</Application>
  <PresentationFormat>A4 210 x 297 mm</PresentationFormat>
  <Paragraphs>9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DengXian</vt:lpstr>
      <vt:lpstr>游明朝</vt:lpstr>
      <vt:lpstr>Arial</vt:lpstr>
      <vt:lpstr>Calibri</vt:lpstr>
      <vt:lpstr>Calibri Light</vt:lpstr>
      <vt:lpstr>Symbol</vt:lpstr>
      <vt:lpstr>Times New Roman</vt:lpstr>
      <vt:lpstr>Office 主题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 ShH</dc:creator>
  <cp:lastModifiedBy>秋 利彦</cp:lastModifiedBy>
  <cp:revision>378</cp:revision>
  <dcterms:created xsi:type="dcterms:W3CDTF">2021-09-17T03:00:21Z</dcterms:created>
  <dcterms:modified xsi:type="dcterms:W3CDTF">2024-06-30T05:01:34Z</dcterms:modified>
</cp:coreProperties>
</file>